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080135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648" y="-90"/>
      </p:cViewPr>
      <p:guideLst>
        <p:guide orient="horz" pos="2160"/>
        <p:guide pos="340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10101" y="2130426"/>
            <a:ext cx="9181148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0203" y="3886200"/>
            <a:ext cx="7560945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ED538-F0DD-48D8-8892-BF27344E6CEC}" type="datetimeFigureOut">
              <a:rPr lang="en-GB" smtClean="0"/>
              <a:t>08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110DA-8E70-471C-AA9A-E95B912CBD5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ED538-F0DD-48D8-8892-BF27344E6CEC}" type="datetimeFigureOut">
              <a:rPr lang="en-GB" smtClean="0"/>
              <a:t>08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110DA-8E70-471C-AA9A-E95B912CBD5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30979" y="274639"/>
            <a:ext cx="2430304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0067" y="274639"/>
            <a:ext cx="7110889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ED538-F0DD-48D8-8892-BF27344E6CEC}" type="datetimeFigureOut">
              <a:rPr lang="en-GB" smtClean="0"/>
              <a:t>08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110DA-8E70-471C-AA9A-E95B912CBD5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ED538-F0DD-48D8-8892-BF27344E6CEC}" type="datetimeFigureOut">
              <a:rPr lang="en-GB" smtClean="0"/>
              <a:t>08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110DA-8E70-471C-AA9A-E95B912CBD5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3232" y="4406901"/>
            <a:ext cx="9181148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3232" y="2906713"/>
            <a:ext cx="9181148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ED538-F0DD-48D8-8892-BF27344E6CEC}" type="datetimeFigureOut">
              <a:rPr lang="en-GB" smtClean="0"/>
              <a:t>08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110DA-8E70-471C-AA9A-E95B912CBD5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0068" y="1600201"/>
            <a:ext cx="477059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90686" y="1600201"/>
            <a:ext cx="477059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ED538-F0DD-48D8-8892-BF27344E6CEC}" type="datetimeFigureOut">
              <a:rPr lang="en-GB" smtClean="0"/>
              <a:t>08/03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110DA-8E70-471C-AA9A-E95B912CBD5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068" y="1535113"/>
            <a:ext cx="477247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0068" y="2174875"/>
            <a:ext cx="477247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86936" y="1535113"/>
            <a:ext cx="477434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86936" y="2174875"/>
            <a:ext cx="477434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ED538-F0DD-48D8-8892-BF27344E6CEC}" type="datetimeFigureOut">
              <a:rPr lang="en-GB" smtClean="0"/>
              <a:t>08/03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110DA-8E70-471C-AA9A-E95B912CBD5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ED538-F0DD-48D8-8892-BF27344E6CEC}" type="datetimeFigureOut">
              <a:rPr lang="en-GB" smtClean="0"/>
              <a:t>08/03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110DA-8E70-471C-AA9A-E95B912CBD5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ED538-F0DD-48D8-8892-BF27344E6CEC}" type="datetimeFigureOut">
              <a:rPr lang="en-GB" smtClean="0"/>
              <a:t>08/03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110DA-8E70-471C-AA9A-E95B912CBD5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068" y="273050"/>
            <a:ext cx="3553570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23028" y="273051"/>
            <a:ext cx="6038255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0068" y="1435101"/>
            <a:ext cx="3553570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ED538-F0DD-48D8-8892-BF27344E6CEC}" type="datetimeFigureOut">
              <a:rPr lang="en-GB" smtClean="0"/>
              <a:t>08/03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110DA-8E70-471C-AA9A-E95B912CBD5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17140" y="4800600"/>
            <a:ext cx="648081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117140" y="612775"/>
            <a:ext cx="648081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17140" y="5367338"/>
            <a:ext cx="648081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ED538-F0DD-48D8-8892-BF27344E6CEC}" type="datetimeFigureOut">
              <a:rPr lang="en-GB" smtClean="0"/>
              <a:t>08/03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110DA-8E70-471C-AA9A-E95B912CBD56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0068" y="274638"/>
            <a:ext cx="9721215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068" y="1600201"/>
            <a:ext cx="9721215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0068" y="6356351"/>
            <a:ext cx="252031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BED538-F0DD-48D8-8892-BF27344E6CEC}" type="datetimeFigureOut">
              <a:rPr lang="en-GB" smtClean="0"/>
              <a:t>08/03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90461" y="6356351"/>
            <a:ext cx="342042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40968" y="6356351"/>
            <a:ext cx="252031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9110DA-8E70-471C-AA9A-E95B912CBD56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0585727"/>
              </p:ext>
            </p:extLst>
          </p:nvPr>
        </p:nvGraphicFramePr>
        <p:xfrm>
          <a:off x="-9" y="1628798"/>
          <a:ext cx="10801354" cy="3220602"/>
        </p:xfrm>
        <a:graphic>
          <a:graphicData uri="http://schemas.openxmlformats.org/drawingml/2006/table">
            <a:tbl>
              <a:tblPr/>
              <a:tblGrid>
                <a:gridCol w="603877"/>
                <a:gridCol w="531338"/>
                <a:gridCol w="458473"/>
                <a:gridCol w="458473"/>
                <a:gridCol w="458473"/>
                <a:gridCol w="238788"/>
                <a:gridCol w="458473"/>
                <a:gridCol w="458473"/>
                <a:gridCol w="458473"/>
                <a:gridCol w="458473"/>
                <a:gridCol w="238788"/>
                <a:gridCol w="458473"/>
                <a:gridCol w="458473"/>
                <a:gridCol w="458473"/>
                <a:gridCol w="458473"/>
                <a:gridCol w="238788"/>
                <a:gridCol w="458473"/>
                <a:gridCol w="458473"/>
                <a:gridCol w="458473"/>
                <a:gridCol w="458473"/>
                <a:gridCol w="238788"/>
                <a:gridCol w="458473"/>
                <a:gridCol w="458473"/>
                <a:gridCol w="458473"/>
                <a:gridCol w="458473"/>
              </a:tblGrid>
              <a:tr h="320984"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B1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B2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oh1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oh2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2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B1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B2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oh1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oh2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2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B1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B2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oh1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oh2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2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B1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B2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oh1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oh2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2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B1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B2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oh1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oh2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0984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Dad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0984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ale 1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</a:tr>
              <a:tr h="320984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ale 2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9277">
                <a:tc>
                  <a:txBody>
                    <a:bodyPr/>
                    <a:lstStyle/>
                    <a:p>
                      <a:pPr algn="ctr" fontAlgn="ctr"/>
                      <a:endParaRPr lang="en-GB" sz="12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9100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um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30061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emale 1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1458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emale 2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E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5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35" marR="4835" marT="40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44865">
                <a:tc>
                  <a:txBody>
                    <a:bodyPr/>
                    <a:lstStyle/>
                    <a:p>
                      <a:pPr algn="ctr" fontAlgn="ctr"/>
                      <a:endParaRPr lang="en-GB" sz="5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hr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7 (8,069,753-8,410,901 </a:t>
                      </a:r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bp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hr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8 (6,403,202-6,514,083 </a:t>
                      </a:r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bp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hr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13 (21,442,953-21,723,595 </a:t>
                      </a:r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bp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hr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15 (13,473,557-13,681,501 </a:t>
                      </a:r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bp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hr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15 (41,665,068-41,824,603 </a:t>
                      </a:r>
                      <a:r>
                        <a:rPr lang="en-GB" sz="1000" b="1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bp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4835" marR="4835" marT="4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 bwMode="auto">
          <a:xfrm>
            <a:off x="454487" y="5611105"/>
            <a:ext cx="437197" cy="280307"/>
          </a:xfrm>
          <a:prstGeom prst="rect">
            <a:avLst/>
          </a:prstGeom>
          <a:solidFill>
            <a:srgbClr val="0070C0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SG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24761" y="5581980"/>
            <a:ext cx="5661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Gain</a:t>
            </a:r>
            <a:endParaRPr lang="en-SG" sz="1600" dirty="0"/>
          </a:p>
        </p:txBody>
      </p:sp>
      <p:sp>
        <p:nvSpPr>
          <p:cNvPr id="7" name="Rectangle 6"/>
          <p:cNvSpPr/>
          <p:nvPr/>
        </p:nvSpPr>
        <p:spPr bwMode="auto">
          <a:xfrm>
            <a:off x="1783202" y="5618365"/>
            <a:ext cx="437197" cy="280307"/>
          </a:xfrm>
          <a:prstGeom prst="rect">
            <a:avLst/>
          </a:prstGeom>
          <a:solidFill>
            <a:srgbClr val="FF0000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SG" sz="2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253476" y="5589240"/>
            <a:ext cx="5405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Loss</a:t>
            </a:r>
            <a:endParaRPr lang="en-SG" sz="1600" dirty="0"/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Figure S4</a:t>
            </a:r>
            <a:endParaRPr lang="en-GB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4</Words>
  <Application>Microsoft Office PowerPoint</Application>
  <PresentationFormat>Custom</PresentationFormat>
  <Paragraphs>17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Figure S4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le 4</dc:title>
  <dc:creator>WC</dc:creator>
  <cp:lastModifiedBy>Liew Woei Chang</cp:lastModifiedBy>
  <cp:revision>3</cp:revision>
  <dcterms:created xsi:type="dcterms:W3CDTF">2011-07-27T15:10:51Z</dcterms:created>
  <dcterms:modified xsi:type="dcterms:W3CDTF">2012-03-08T04:46:57Z</dcterms:modified>
</cp:coreProperties>
</file>